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-1320" y="-91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___1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___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iological Process</a:t>
            </a:r>
            <a:endParaRPr lang="zh-CN" altLang="en-US" sz="1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view3D>
      <c:rotX val="30"/>
      <c:rotY val="0"/>
      <c:depthPercent val="100"/>
      <c:rAngAx val="0"/>
      <c:perspective val="3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4056984402955494"/>
          <c:y val="0.1583647694995389"/>
          <c:w val="0.73257408872487018"/>
          <c:h val="0.27881601501460568"/>
        </c:manualLayout>
      </c:layout>
      <c:pie3DChart>
        <c:varyColors val="1"/>
        <c:ser>
          <c:idx val="0"/>
          <c:order val="0"/>
          <c:explosion val="20"/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19A-4353-87FA-FB45826D8D86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219A-4353-87FA-FB45826D8D86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219A-4353-87FA-FB45826D8D86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219A-4353-87FA-FB45826D8D86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219A-4353-87FA-FB45826D8D86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219A-4353-87FA-FB45826D8D86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219A-4353-87FA-FB45826D8D86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219A-4353-87FA-FB45826D8D86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219A-4353-87FA-FB45826D8D86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219A-4353-87FA-FB45826D8D86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2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Sheet1!$C$1:$C$10</c:f>
              <c:strCache>
                <c:ptCount val="10"/>
                <c:pt idx="0">
                  <c:v>oxidation-reduction process</c:v>
                </c:pt>
                <c:pt idx="1">
                  <c:v>metabolic process</c:v>
                </c:pt>
                <c:pt idx="2">
                  <c:v>proteolysis</c:v>
                </c:pt>
                <c:pt idx="3">
                  <c:v>translation</c:v>
                </c:pt>
                <c:pt idx="4">
                  <c:v>protein phosphorylation</c:v>
                </c:pt>
                <c:pt idx="5">
                  <c:v>carbohydrate metabolic process</c:v>
                </c:pt>
                <c:pt idx="6">
                  <c:v>response to oxidative stress</c:v>
                </c:pt>
                <c:pt idx="7">
                  <c:v>protein folding</c:v>
                </c:pt>
                <c:pt idx="8">
                  <c:v>intracellular protein transport</c:v>
                </c:pt>
                <c:pt idx="9">
                  <c:v>cell redox homeostasis</c:v>
                </c:pt>
              </c:strCache>
            </c:strRef>
          </c:cat>
          <c:val>
            <c:numRef>
              <c:f>Sheet1!$D$1:$D$10</c:f>
              <c:numCache>
                <c:formatCode>General</c:formatCode>
                <c:ptCount val="10"/>
                <c:pt idx="0">
                  <c:v>525</c:v>
                </c:pt>
                <c:pt idx="1">
                  <c:v>280</c:v>
                </c:pt>
                <c:pt idx="2">
                  <c:v>163</c:v>
                </c:pt>
                <c:pt idx="3">
                  <c:v>161</c:v>
                </c:pt>
                <c:pt idx="4">
                  <c:v>159</c:v>
                </c:pt>
                <c:pt idx="5">
                  <c:v>156</c:v>
                </c:pt>
                <c:pt idx="6">
                  <c:v>89</c:v>
                </c:pt>
                <c:pt idx="7">
                  <c:v>81</c:v>
                </c:pt>
                <c:pt idx="8">
                  <c:v>76</c:v>
                </c:pt>
                <c:pt idx="9">
                  <c:v>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4-219A-4353-87FA-FB45826D8D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 w="25400"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</c:legendEntry>
      <c:legendEntry>
        <c:idx val="6"/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</c:legendEntry>
      <c:layout>
        <c:manualLayout>
          <c:xMode val="edge"/>
          <c:yMode val="edge"/>
          <c:x val="0"/>
          <c:y val="0.45846551307835043"/>
          <c:w val="1"/>
          <c:h val="0.5241950294020246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zh-CN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lecular Function</a:t>
            </a:r>
            <a:endParaRPr lang="zh-CN" altLang="en-US" sz="1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240265223157508"/>
          <c:y val="1.9396199697443342E-2"/>
        </c:manualLayout>
      </c:layout>
      <c:overlay val="0"/>
      <c:spPr>
        <a:noFill/>
        <a:ln>
          <a:noFill/>
        </a:ln>
        <a:effectLst/>
      </c:spPr>
    </c:title>
    <c:autoTitleDeleted val="0"/>
    <c:view3D>
      <c:rotX val="30"/>
      <c:rotY val="0"/>
      <c:depthPercent val="100"/>
      <c:rAngAx val="0"/>
      <c:perspective val="3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24290831324869031"/>
          <c:y val="0.14748551270481716"/>
          <c:w val="0.73105993963504312"/>
          <c:h val="0.30158558504806726"/>
        </c:manualLayout>
      </c:layout>
      <c:pie3DChart>
        <c:varyColors val="1"/>
        <c:ser>
          <c:idx val="0"/>
          <c:order val="0"/>
          <c:explosion val="20"/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31CE-4DE5-9326-7E1286F365FC}"/>
              </c:ext>
            </c:extLst>
          </c:dPt>
          <c:dPt>
            <c:idx val="1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31CE-4DE5-9326-7E1286F365FC}"/>
              </c:ext>
            </c:extLst>
          </c:dPt>
          <c:dPt>
            <c:idx val="2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31CE-4DE5-9326-7E1286F365FC}"/>
              </c:ext>
            </c:extLst>
          </c:dPt>
          <c:dPt>
            <c:idx val="3"/>
            <c:bubble3D val="0"/>
            <c:spPr>
              <a:solidFill>
                <a:schemeClr val="accent1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31CE-4DE5-9326-7E1286F365FC}"/>
              </c:ext>
            </c:extLst>
          </c:dPt>
          <c:dPt>
            <c:idx val="4"/>
            <c:bubble3D val="0"/>
            <c:spPr>
              <a:solidFill>
                <a:schemeClr val="accent3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31CE-4DE5-9326-7E1286F365FC}"/>
              </c:ext>
            </c:extLst>
          </c:dPt>
          <c:dPt>
            <c:idx val="5"/>
            <c:bubble3D val="0"/>
            <c:spPr>
              <a:solidFill>
                <a:schemeClr val="accent5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31CE-4DE5-9326-7E1286F365FC}"/>
              </c:ext>
            </c:extLst>
          </c:dPt>
          <c:dPt>
            <c:idx val="6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31CE-4DE5-9326-7E1286F365FC}"/>
              </c:ext>
            </c:extLst>
          </c:dPt>
          <c:dPt>
            <c:idx val="7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31CE-4DE5-9326-7E1286F365FC}"/>
              </c:ext>
            </c:extLst>
          </c:dPt>
          <c:dPt>
            <c:idx val="8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31CE-4DE5-9326-7E1286F365FC}"/>
              </c:ext>
            </c:extLst>
          </c:dPt>
          <c:dPt>
            <c:idx val="9"/>
            <c:bubble3D val="0"/>
            <c:spPr>
              <a:solidFill>
                <a:schemeClr val="accent1">
                  <a:lumMod val="8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31CE-4DE5-9326-7E1286F365FC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2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Sheet1!$C$14:$C$23</c:f>
              <c:strCache>
                <c:ptCount val="10"/>
                <c:pt idx="0">
                  <c:v>ATP binding</c:v>
                </c:pt>
                <c:pt idx="1">
                  <c:v>protein binding</c:v>
                </c:pt>
                <c:pt idx="2">
                  <c:v>nucleic acid binding</c:v>
                </c:pt>
                <c:pt idx="3">
                  <c:v>oxidoreductase activity</c:v>
                </c:pt>
                <c:pt idx="4">
                  <c:v>protein kinase activity</c:v>
                </c:pt>
                <c:pt idx="5">
                  <c:v>structural constituent of ribosome</c:v>
                </c:pt>
                <c:pt idx="6">
                  <c:v>catalytic activity</c:v>
                </c:pt>
                <c:pt idx="7">
                  <c:v>heme binding</c:v>
                </c:pt>
                <c:pt idx="8">
                  <c:v>GTP binding</c:v>
                </c:pt>
                <c:pt idx="9">
                  <c:v>metal ion binding</c:v>
                </c:pt>
              </c:strCache>
            </c:strRef>
          </c:cat>
          <c:val>
            <c:numRef>
              <c:f>Sheet1!$D$14:$D$23</c:f>
              <c:numCache>
                <c:formatCode>General</c:formatCode>
                <c:ptCount val="10"/>
                <c:pt idx="0">
                  <c:v>516</c:v>
                </c:pt>
                <c:pt idx="1">
                  <c:v>453</c:v>
                </c:pt>
                <c:pt idx="2">
                  <c:v>230</c:v>
                </c:pt>
                <c:pt idx="3">
                  <c:v>217</c:v>
                </c:pt>
                <c:pt idx="4">
                  <c:v>159</c:v>
                </c:pt>
                <c:pt idx="5">
                  <c:v>157</c:v>
                </c:pt>
                <c:pt idx="6">
                  <c:v>157</c:v>
                </c:pt>
                <c:pt idx="7">
                  <c:v>127</c:v>
                </c:pt>
                <c:pt idx="8">
                  <c:v>117</c:v>
                </c:pt>
                <c:pt idx="9">
                  <c:v>1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4-31CE-4DE5-9326-7E1286F365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"/>
          <c:y val="0.45828330213375296"/>
          <c:w val="1"/>
          <c:h val="0.5147152634313572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zh-CN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r>
              <a:rPr lang="en-US" sz="1200">
                <a:latin typeface="Times New Roman" pitchFamily="18" charset="0"/>
                <a:cs typeface="Times New Roman" pitchFamily="18" charset="0"/>
              </a:rPr>
              <a:t>Cellular Component</a:t>
            </a:r>
            <a:endParaRPr lang="zh-CN" sz="1200">
              <a:latin typeface="Times New Roman" pitchFamily="18" charset="0"/>
              <a:cs typeface="Times New Roman" pitchFamily="18" charset="0"/>
            </a:endParaRP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view3D>
      <c:rotX val="30"/>
      <c:rotY val="0"/>
      <c:depthPercent val="100"/>
      <c:rAngAx val="0"/>
      <c:perspective val="3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9.9826138037870646E-2"/>
          <c:y val="0.16286031786281632"/>
          <c:w val="0.7268080617628434"/>
          <c:h val="0.28057695606452721"/>
        </c:manualLayout>
      </c:layout>
      <c:pie3DChart>
        <c:varyColors val="1"/>
        <c:ser>
          <c:idx val="0"/>
          <c:order val="0"/>
          <c:explosion val="20"/>
          <c:dPt>
            <c:idx val="0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66E-4C45-BB50-C11406D66F0A}"/>
              </c:ext>
            </c:extLst>
          </c:dPt>
          <c:dPt>
            <c:idx val="1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66E-4C45-BB50-C11406D66F0A}"/>
              </c:ext>
            </c:extLst>
          </c:dPt>
          <c:dPt>
            <c:idx val="2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66E-4C45-BB50-C11406D66F0A}"/>
              </c:ext>
            </c:extLst>
          </c:dPt>
          <c:dPt>
            <c:idx val="3"/>
            <c:bubble3D val="0"/>
            <c:spPr>
              <a:solidFill>
                <a:schemeClr val="accent6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466E-4C45-BB50-C11406D66F0A}"/>
              </c:ext>
            </c:extLst>
          </c:dPt>
          <c:dPt>
            <c:idx val="4"/>
            <c:bubble3D val="0"/>
            <c:spPr>
              <a:solidFill>
                <a:schemeClr val="accent5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466E-4C45-BB50-C11406D66F0A}"/>
              </c:ext>
            </c:extLst>
          </c:dPt>
          <c:dPt>
            <c:idx val="5"/>
            <c:bubble3D val="0"/>
            <c:spPr>
              <a:solidFill>
                <a:schemeClr val="accent4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466E-4C45-BB50-C11406D66F0A}"/>
              </c:ext>
            </c:extLst>
          </c:dPt>
          <c:dPt>
            <c:idx val="6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466E-4C45-BB50-C11406D66F0A}"/>
              </c:ext>
            </c:extLst>
          </c:dPt>
          <c:dPt>
            <c:idx val="7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466E-4C45-BB50-C11406D66F0A}"/>
              </c:ext>
            </c:extLst>
          </c:dPt>
          <c:dPt>
            <c:idx val="8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466E-4C45-BB50-C11406D66F0A}"/>
              </c:ext>
            </c:extLst>
          </c:dPt>
          <c:dPt>
            <c:idx val="9"/>
            <c:bubble3D val="0"/>
            <c:spPr>
              <a:solidFill>
                <a:schemeClr val="accent6">
                  <a:lumMod val="8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466E-4C45-BB50-C11406D66F0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200" b="1">
                    <a:latin typeface="Times New Roman" pitchFamily="18" charset="0"/>
                    <a:cs typeface="Times New Roman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Sheet1!$C$27:$C$36</c:f>
              <c:strCache>
                <c:ptCount val="10"/>
                <c:pt idx="0">
                  <c:v>ribosome</c:v>
                </c:pt>
                <c:pt idx="1">
                  <c:v>membrane</c:v>
                </c:pt>
                <c:pt idx="2">
                  <c:v>intracellular</c:v>
                </c:pt>
                <c:pt idx="3">
                  <c:v>cytoplasm</c:v>
                </c:pt>
                <c:pt idx="4">
                  <c:v>integral component of membrane</c:v>
                </c:pt>
                <c:pt idx="5">
                  <c:v>nucleus</c:v>
                </c:pt>
                <c:pt idx="6">
                  <c:v>proteasome core complex</c:v>
                </c:pt>
                <c:pt idx="7">
                  <c:v>photosystem II</c:v>
                </c:pt>
                <c:pt idx="8">
                  <c:v>photosystem II oxygen evolving complex</c:v>
                </c:pt>
                <c:pt idx="9">
                  <c:v>nucleosome</c:v>
                </c:pt>
              </c:strCache>
            </c:strRef>
          </c:cat>
          <c:val>
            <c:numRef>
              <c:f>Sheet1!$D$27:$D$36</c:f>
              <c:numCache>
                <c:formatCode>General</c:formatCode>
                <c:ptCount val="10"/>
                <c:pt idx="0">
                  <c:v>150</c:v>
                </c:pt>
                <c:pt idx="1">
                  <c:v>144</c:v>
                </c:pt>
                <c:pt idx="2">
                  <c:v>140</c:v>
                </c:pt>
                <c:pt idx="3">
                  <c:v>128</c:v>
                </c:pt>
                <c:pt idx="4">
                  <c:v>109</c:v>
                </c:pt>
                <c:pt idx="5">
                  <c:v>88</c:v>
                </c:pt>
                <c:pt idx="6">
                  <c:v>24</c:v>
                </c:pt>
                <c:pt idx="7">
                  <c:v>23</c:v>
                </c:pt>
                <c:pt idx="8">
                  <c:v>21</c:v>
                </c:pt>
                <c:pt idx="9">
                  <c:v>2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4-466E-4C45-BB50-C11406D66F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</c:pie3D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"/>
          <c:y val="0.455991935343531"/>
          <c:w val="1"/>
          <c:h val="0.52655767944730747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 sz="1200">
              <a:solidFill>
                <a:schemeClr val="tx1"/>
              </a:solidFill>
            </a:defRPr>
          </a:pPr>
          <a:endParaRPr lang="zh-CN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zh-CN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1</cdr:x>
      <cdr:y>1</cdr:y>
    </cdr:to>
    <cdr:sp macro="" textlink="">
      <cdr:nvSpPr>
        <cdr:cNvPr id="2" name="矩形 1">
          <a:extLst xmlns:a="http://schemas.openxmlformats.org/drawingml/2006/main">
            <a:ext uri="{FF2B5EF4-FFF2-40B4-BE49-F238E27FC236}">
              <a16:creationId xmlns="" xmlns:a16="http://schemas.microsoft.com/office/drawing/2014/main" id="{738D4F0B-E208-4F0E-B289-586923CA3704}"/>
            </a:ext>
          </a:extLst>
        </cdr:cNvPr>
        <cdr:cNvSpPr/>
      </cdr:nvSpPr>
      <cdr:spPr>
        <a:xfrm xmlns:a="http://schemas.openxmlformats.org/drawingml/2006/main">
          <a:off x="0" y="0"/>
          <a:ext cx="3063002" cy="4013159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2773</cdr:x>
      <cdr:y>0</cdr:y>
    </cdr:from>
    <cdr:to>
      <cdr:x>1</cdr:x>
      <cdr:y>1</cdr:y>
    </cdr:to>
    <cdr:sp macro="" textlink="">
      <cdr:nvSpPr>
        <cdr:cNvPr id="2" name="矩形 1">
          <a:extLst xmlns:a="http://schemas.openxmlformats.org/drawingml/2006/main">
            <a:ext uri="{FF2B5EF4-FFF2-40B4-BE49-F238E27FC236}">
              <a16:creationId xmlns="" xmlns:a16="http://schemas.microsoft.com/office/drawing/2014/main" id="{1740B874-9913-405B-904C-43B67F4BAE21}"/>
            </a:ext>
          </a:extLst>
        </cdr:cNvPr>
        <cdr:cNvSpPr/>
      </cdr:nvSpPr>
      <cdr:spPr>
        <a:xfrm xmlns:a="http://schemas.openxmlformats.org/drawingml/2006/main">
          <a:off x="108076" y="0"/>
          <a:ext cx="3788915" cy="685800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</cdr:x>
      <cdr:y>0</cdr:y>
    </cdr:from>
    <cdr:to>
      <cdr:x>1</cdr:x>
      <cdr:y>1</cdr:y>
    </cdr:to>
    <cdr:sp macro="" textlink="">
      <cdr:nvSpPr>
        <cdr:cNvPr id="3" name="矩形 2">
          <a:extLst xmlns:a="http://schemas.openxmlformats.org/drawingml/2006/main">
            <a:ext uri="{FF2B5EF4-FFF2-40B4-BE49-F238E27FC236}">
              <a16:creationId xmlns="" xmlns:a16="http://schemas.microsoft.com/office/drawing/2014/main" id="{3646EE4A-4407-42A3-9034-64422E06A0E8}"/>
            </a:ext>
          </a:extLst>
        </cdr:cNvPr>
        <cdr:cNvSpPr/>
      </cdr:nvSpPr>
      <cdr:spPr>
        <a:xfrm xmlns:a="http://schemas.openxmlformats.org/drawingml/2006/main">
          <a:off x="0" y="0"/>
          <a:ext cx="3065425" cy="4022490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>
            <a:solidFill>
              <a:schemeClr val="tx1"/>
            </a:solidFill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F8D71A-4436-4779-A6BD-AD3ABF78C727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15A903-F889-400F-B1C5-40962446C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184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15A903-F889-400F-B1C5-40962446C94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1595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65678BA8-832D-46F5-8964-B5004C1B40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38250" y="1122363"/>
            <a:ext cx="74295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560BFFF1-ABBE-4D72-9818-036C00C50D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D679F7CD-5E25-412F-96D3-B8490E15FC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E69D9-1D69-4922-A4E5-DE9239EFABB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D99C7322-F08B-40D1-9E22-5F9295092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9644ED01-009C-4E41-9EEF-F432C074D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F19-47EC-4345-89F3-EBACC14FC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357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40F6D296-D39C-4BB8-B279-7F0E84ECC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61F8F4C9-78B5-46D6-97EB-F3DA31701E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7BC314CA-B0B7-4FC9-8924-70FD531FF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E69D9-1D69-4922-A4E5-DE9239EFABB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FF51BA8B-B453-4E85-BE48-83B9549E3D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A3B0EF00-58E1-412F-A231-B06FE357B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F19-47EC-4345-89F3-EBACC14FC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410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30B17793-F13A-4522-9C4D-6044DF9503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7088981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3C9F78D4-A7A4-42B2-BD83-7B6A05FE44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81037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BAAACF73-4235-4561-BD77-EAD076967F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E69D9-1D69-4922-A4E5-DE9239EFABB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8A2A8634-1879-48DF-BF76-CFE35BDAF6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D57011B-ED92-4559-9A7A-140715905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F19-47EC-4345-89F3-EBACC14FC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364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AF090C24-7163-4B1A-8AFC-9D45AEFF78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300B4D7F-1DAA-4028-A2C5-D4D34460AF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3D65B6F9-7AFF-4E68-9E5F-863A6FE15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E69D9-1D69-4922-A4E5-DE9239EFABB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48C3661D-F434-4482-AC59-55AFA281B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26A68DEE-D1E4-492B-8C61-D8734315E1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F19-47EC-4345-89F3-EBACC14FC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797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414AF7A9-E52F-4B6D-B2CE-F0348501A4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75878" y="1709738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5A621A0A-CAE1-4FC7-A126-F6C512F3DB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75878" y="4589464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A2F7DC6C-75C6-448A-BC29-9D554EBAF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E69D9-1D69-4922-A4E5-DE9239EFABB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92E75396-5844-483D-B4FB-4EB8CAFC7A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6EDDDF40-CC3D-4405-B822-65939FDCA9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F19-47EC-4345-89F3-EBACC14FC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2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7E61BD45-4670-49B9-AFE0-B6DD595012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BF403B2E-9285-44E6-A992-D57F01B7F9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69993BEE-E922-4310-826F-DBEF9DB100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F8641B5B-68A6-458F-B246-3D2377AC9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E69D9-1D69-4922-A4E5-DE9239EFABB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67B10DCB-6867-491A-9F9A-3184FCC8BA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D0C2810D-5FD6-42A4-BD00-21C44B6EE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F19-47EC-4345-89F3-EBACC14FC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86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4EA65F61-F42A-4940-80FA-45416A2D8C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365126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29F344DA-3053-442D-A14C-8DC4F54AAA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2328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EFCA91E1-CE16-4F76-8C36-B3C89A5818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82328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83A678FA-835A-4F89-A2CE-98402E076E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02262BEE-B1FD-4267-81FA-2FB7F4D9D0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A638E661-0EAE-45D5-87ED-6F178D55A2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E69D9-1D69-4922-A4E5-DE9239EFABB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FCE2462B-7511-446A-9719-A7EBE24249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CD62F60C-930E-4D2C-ABE4-8DF0300F32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F19-47EC-4345-89F3-EBACC14FC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4031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3E02F430-529C-492D-B749-FAB1FECDA2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0F3FAC4C-17F7-45CC-9272-4E9C483B4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E69D9-1D69-4922-A4E5-DE9239EFABB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50F1EA17-B7FA-4F99-A8F1-F836BFA7C6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EBDA2459-447C-4924-B15D-781F9728A4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F19-47EC-4345-89F3-EBACC14FC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851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82682DB0-79E5-4CD9-BD73-CE0A40E7F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E69D9-1D69-4922-A4E5-DE9239EFABB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C7742113-148A-4519-B6F3-9354E99FC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5B99CB68-2B39-43C5-9201-CA738DF08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F19-47EC-4345-89F3-EBACC14FC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938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624D0DD1-EA91-400B-B64C-B87DE7C262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36827121-8EDD-4947-84C5-2F28040904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FFE2E026-051D-41CA-80A2-B1C337DD85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D2FC3EA4-E663-4077-9E40-DF31E051B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E69D9-1D69-4922-A4E5-DE9239EFABB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5F946077-6C1E-463E-B097-8EDC62CDD2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20A4E9A8-4318-4904-8CB1-008A1EA036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F19-47EC-4345-89F3-EBACC14FC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124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06455BA9-C601-4560-8D09-7019E2D3E3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28B0197D-C82E-4DD8-B60D-0D634C3216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7E680B7B-9CE3-4225-8F63-1AEE4D7E42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A1062427-5681-4ADD-B939-DAC325BB3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E69D9-1D69-4922-A4E5-DE9239EFABB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990D034F-9380-4B42-85A7-A7DFB022B1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9D5AA216-3F89-452B-B25A-4FC6C85AB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1EF19-47EC-4345-89F3-EBACC14FC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51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9A7B8D56-EC17-4B79-AC12-C18796FD4E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0A46012C-CE4B-4B8F-BA46-27E18A25D4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F81F0E2E-2256-4BB2-8604-8F6C33E073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81038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BE69D9-1D69-4922-A4E5-DE9239EFABB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DAF66819-C2D2-42F9-9B49-83ACB9FD75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281363" y="6356351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53309F95-0A6E-4728-B204-D94E619E22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996113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41EF19-47EC-4345-89F3-EBACC14FC4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924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="" xmlns:a16="http://schemas.microsoft.com/office/drawing/2014/main" id="{025667DC-C28F-4BC9-B61A-9868F4056D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8439053"/>
              </p:ext>
            </p:extLst>
          </p:nvPr>
        </p:nvGraphicFramePr>
        <p:xfrm>
          <a:off x="167951" y="838784"/>
          <a:ext cx="3063002" cy="40131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图表 4">
            <a:extLst>
              <a:ext uri="{FF2B5EF4-FFF2-40B4-BE49-F238E27FC236}">
                <a16:creationId xmlns="" xmlns:a16="http://schemas.microsoft.com/office/drawing/2014/main" id="{4BB5870D-70EA-4E7D-878D-605178E8AE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287369"/>
              </p:ext>
            </p:extLst>
          </p:nvPr>
        </p:nvGraphicFramePr>
        <p:xfrm>
          <a:off x="6619750" y="848114"/>
          <a:ext cx="3065425" cy="40224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图表 5">
            <a:extLst>
              <a:ext uri="{FF2B5EF4-FFF2-40B4-BE49-F238E27FC236}">
                <a16:creationId xmlns="" xmlns:a16="http://schemas.microsoft.com/office/drawing/2014/main" id="{63C7F724-2E9C-41D5-9639-7AF77793C7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6325918"/>
              </p:ext>
            </p:extLst>
          </p:nvPr>
        </p:nvGraphicFramePr>
        <p:xfrm>
          <a:off x="3387012" y="838785"/>
          <a:ext cx="3060441" cy="40224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77280" y="850574"/>
            <a:ext cx="429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396341" y="849118"/>
            <a:ext cx="429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624732" y="850574"/>
            <a:ext cx="429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70588" y="5228434"/>
            <a:ext cx="923730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ure S1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op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en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gene ontology (GO) of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ll proteins identified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in two sugarcane cultivars inoculated with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Xanthomonas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albilinean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LCP85-384 resistant and ROC20 susceptible to leaf scald). (A) Biological process, (B) Cellular component, and (C) Molecular function.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7928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</TotalTime>
  <Words>60</Words>
  <Application>Microsoft Office PowerPoint</Application>
  <PresentationFormat>A4 纸张(210x297 毫米)</PresentationFormat>
  <Paragraphs>8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GSJ</cp:lastModifiedBy>
  <cp:revision>13</cp:revision>
  <dcterms:created xsi:type="dcterms:W3CDTF">2019-09-20T02:05:40Z</dcterms:created>
  <dcterms:modified xsi:type="dcterms:W3CDTF">2019-12-14T02:53:39Z</dcterms:modified>
</cp:coreProperties>
</file>